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1" r:id="rId2"/>
    <p:sldId id="263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1DE7FB7-D84A-F447-867F-2CD78AC19A9B}" v="64" dt="2023-09-28T16:01:51.05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397"/>
    <p:restoredTop sz="95056"/>
  </p:normalViewPr>
  <p:slideViewPr>
    <p:cSldViewPr snapToGrid="0">
      <p:cViewPr varScale="1">
        <p:scale>
          <a:sx n="143" d="100"/>
          <a:sy n="143" d="100"/>
        </p:scale>
        <p:origin x="216" y="3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FF7743-B154-8B4F-8402-6E55D2D17121}" type="datetimeFigureOut">
              <a:rPr lang="en-US" smtClean="0"/>
              <a:t>9/28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9791B2-8DFA-D747-A275-370871B28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5669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4927E3-74E7-684B-82F6-7F35E7D9553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5508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4927E3-74E7-684B-82F6-7F35E7D9553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0352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A63774-DE7A-FEF1-9C5B-61EC691500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34E6D1-9267-D318-AFA7-C576A32F91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F686BC-8514-DEDE-7D58-424284D8B6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2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EE7012-EEB8-4A8E-ADB7-A31D1D777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2A3893-5D2F-A004-474E-7D0DCDDB0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825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F0CA10-1057-6881-DAD9-2A3E7C0495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0DA373-240D-A18E-FCB2-B9B954706A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480D00-EECA-A57D-15FA-168B980166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2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09F343-42F8-7476-617C-1DB987C5BF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D7FD80-8366-4CF8-06F7-65204C660A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8450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3AD3DA8-5205-658A-B5B6-3D9D8E0871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2D92A76-B4C2-756C-260F-495003E0FE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AF1C4B-9EDB-4472-5DC0-D25A64C667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2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908F08-FC9F-DF77-8187-F222C83815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519E5A-3997-C3AB-EEE2-E2F00DD43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387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232D98-5B84-4A7F-883D-8392C8D8F6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1164FA-2C1A-FE49-DA1A-307C48AC99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894250-F94F-8506-1BFE-01A03500D6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2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1E470C-BAC3-284F-1920-84A2F0D73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814295-CB19-16F1-745F-69F20E6626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330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91B4C1-1445-4C67-EC8D-8617DC0CA8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68149F-829D-AC45-3CC1-DFC3E2E0AE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48C152-6C17-EA02-47FF-9594BC5264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2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7B7F9A-8DD4-7FCC-B53C-5E0934707D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60097E-254D-FCA4-8464-F00DAA146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930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6FF1B6-24B5-C8DE-B4E0-4D2246C425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583E25-7372-D667-333D-4A3EC0F4C0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1A6F42-7BCB-02E4-F695-EAE3682B45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9EA269-E8D8-2E3C-D42E-FA51C68CF4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2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A98E5E-C55C-B1EB-CA9B-C2B5C0E685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8CF63B-D576-F8C2-38B7-5199D7440C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76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A3673F-8E7B-B249-7CF2-E98B89B5E2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4ED33B-3918-BF12-F876-B045840D1E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BB4936-CCD2-3532-376C-D85D7DB88C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47ED8B-705A-A2D5-58BD-264E433389B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B4760F0-0654-2E9E-7870-E0A2466FA9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E1A41CF-C22D-3072-65DB-123B5FA44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28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81FF783-6C5E-6F50-7A6A-E14E64404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12B5F7-1558-423B-D615-6147550AF3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6255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9B5FEF-C65F-30BC-90F7-FE9523EA55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A4C5B0D-791F-C271-502C-44942E2DE3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28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47AF4AE-AAF6-D79A-7232-41094FF92C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AB764C6-0625-6DA6-8AE1-F78EEF1D6D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5855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458C202-07F3-BE7B-FF0D-AB0933963E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28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2CF2583-6AE9-9018-E26D-655E42D32F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C256DC-7F2A-0F8A-90FB-04C1D52DA1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2977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837707-A3B7-EBD8-3E92-1A623EC8CB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8292F9-CB07-EF92-0582-4AAB75FA17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9BD70F8-6061-598A-C3B7-6C6F974F3F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83A267-E1CC-735B-7DC1-E5565C5877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2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A24F4C-5634-590D-2295-302FC27A02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C13BD6-0054-35EE-373D-C7E4D8EE5D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050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5D24A6-496E-5D78-5E1C-4D7200A69B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48F9212-3E95-9F71-DABF-F0F0DE969F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7EE2D3-9EE4-FE83-EBBD-94FD40386D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38C120-D1A7-2810-27EB-62191E0E0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5BE11-6C2A-4E4B-90B9-CDFBE41871DE}" type="datetimeFigureOut">
              <a:rPr lang="en-US" smtClean="0"/>
              <a:t>9/28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D69721-5BE5-7DFD-F5F0-3FE3CBA6C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2AB731-00A4-EC5E-E6B2-D50E9F10B5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500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39C4D58-82C2-E506-676E-07DA08998C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309700-9263-CA0F-29AD-AB01A737B1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60DE43-9415-2272-8999-B7178C5717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45BE11-6C2A-4E4B-90B9-CDFBE41871DE}" type="datetimeFigureOut">
              <a:rPr lang="en-US" smtClean="0"/>
              <a:t>9/28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82DBC9-9BCA-378F-1BB7-B8E0769216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D668D5-D3FB-1133-D2A6-6077082F699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FA3333-5C2E-7A41-95BA-1C2C21D19F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024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microsoft.com/office/2007/relationships/hdphoto" Target="../media/hdphoto4.wdp"/><Relationship Id="rId5" Type="http://schemas.openxmlformats.org/officeDocument/2006/relationships/image" Target="../media/image4.png"/><Relationship Id="rId4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C5B2A98-1A99-D6D7-79F4-0AC3634FB316}"/>
              </a:ext>
            </a:extLst>
          </p:cNvPr>
          <p:cNvSpPr txBox="1"/>
          <p:nvPr/>
        </p:nvSpPr>
        <p:spPr>
          <a:xfrm>
            <a:off x="332442" y="1148233"/>
            <a:ext cx="1776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$ Total FF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30245B5-E599-D50F-7A48-B2A4886489CD}"/>
              </a:ext>
            </a:extLst>
          </p:cNvPr>
          <p:cNvSpPr txBox="1"/>
          <p:nvPr/>
        </p:nvSpPr>
        <p:spPr>
          <a:xfrm>
            <a:off x="6373158" y="1148234"/>
            <a:ext cx="16094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$ Part 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FEF91FA-443F-86FA-0F09-51DEC24CBC85}"/>
              </a:ext>
            </a:extLst>
          </p:cNvPr>
          <p:cNvSpPr txBox="1"/>
          <p:nvPr/>
        </p:nvSpPr>
        <p:spPr>
          <a:xfrm>
            <a:off x="242014" y="233436"/>
            <a:ext cx="93306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ppendix Figure 1.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esidual Analyses for 4 Healthcare Expenditures</a:t>
            </a:r>
            <a:endParaRPr lang="en-US" sz="1800" kern="1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24" name="Picture 23" descr="A collage of graphs and diagrams&#10;&#10;Description automatically generated">
            <a:extLst>
              <a:ext uri="{FF2B5EF4-FFF2-40B4-BE49-F238E27FC236}">
                <a16:creationId xmlns:a16="http://schemas.microsoft.com/office/drawing/2014/main" id="{399380A4-1D0E-F09E-6692-577682603F3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32442" y="1593476"/>
            <a:ext cx="5486433" cy="3962400"/>
          </a:xfrm>
          <a:prstGeom prst="rect">
            <a:avLst/>
          </a:prstGeom>
        </p:spPr>
      </p:pic>
      <p:pic>
        <p:nvPicPr>
          <p:cNvPr id="26" name="Picture 25" descr="A collage of graphs and diagrams&#10;&#10;Description automatically generated">
            <a:extLst>
              <a:ext uri="{FF2B5EF4-FFF2-40B4-BE49-F238E27FC236}">
                <a16:creationId xmlns:a16="http://schemas.microsoft.com/office/drawing/2014/main" id="{B08849FC-29D7-D9D6-572F-15AC3C3F67DB}"/>
              </a:ext>
            </a:extLst>
          </p:cNvPr>
          <p:cNvPicPr>
            <a:picLocks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373158" y="1596524"/>
            <a:ext cx="5486400" cy="39593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57919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C5B2A98-1A99-D6D7-79F4-0AC3634FB316}"/>
              </a:ext>
            </a:extLst>
          </p:cNvPr>
          <p:cNvSpPr txBox="1"/>
          <p:nvPr/>
        </p:nvSpPr>
        <p:spPr>
          <a:xfrm>
            <a:off x="332442" y="1148233"/>
            <a:ext cx="1776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$ Part 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30245B5-E599-D50F-7A48-B2A4886489CD}"/>
              </a:ext>
            </a:extLst>
          </p:cNvPr>
          <p:cNvSpPr txBox="1"/>
          <p:nvPr/>
        </p:nvSpPr>
        <p:spPr>
          <a:xfrm>
            <a:off x="6373158" y="1148234"/>
            <a:ext cx="16094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$ Part D</a:t>
            </a:r>
          </a:p>
        </p:txBody>
      </p:sp>
      <p:pic>
        <p:nvPicPr>
          <p:cNvPr id="2" name="Picture 1" descr="A collage of graphs and diagrams&#10;&#10;Description automatically generated">
            <a:extLst>
              <a:ext uri="{FF2B5EF4-FFF2-40B4-BE49-F238E27FC236}">
                <a16:creationId xmlns:a16="http://schemas.microsoft.com/office/drawing/2014/main" id="{F5D84E87-390F-CF2E-F63C-A307CDD6CE90}"/>
              </a:ext>
            </a:extLst>
          </p:cNvPr>
          <p:cNvPicPr>
            <a:picLocks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32442" y="1596523"/>
            <a:ext cx="5486400" cy="3959352"/>
          </a:xfrm>
          <a:prstGeom prst="rect">
            <a:avLst/>
          </a:prstGeom>
        </p:spPr>
      </p:pic>
      <p:pic>
        <p:nvPicPr>
          <p:cNvPr id="3" name="Picture 2" descr="A collage of graphs and diagrams&#10;&#10;Description automatically generated">
            <a:extLst>
              <a:ext uri="{FF2B5EF4-FFF2-40B4-BE49-F238E27FC236}">
                <a16:creationId xmlns:a16="http://schemas.microsoft.com/office/drawing/2014/main" id="{DCDA4270-576D-6F2D-C9FC-84008FFE80BB}"/>
              </a:ext>
            </a:extLst>
          </p:cNvPr>
          <p:cNvPicPr>
            <a:picLocks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373158" y="1596523"/>
            <a:ext cx="5486400" cy="39593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6459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4b77578-9773-42d5-8507-251ca2dc2b06}" enabled="0" method="" siteId="{14b77578-9773-42d5-8507-251ca2dc2b06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242</TotalTime>
  <Words>32</Words>
  <Application>Microsoft Macintosh PowerPoint</Application>
  <PresentationFormat>Widescreen</PresentationFormat>
  <Paragraphs>7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ik, Seo (NIH/NLM/LHC) [E]</dc:creator>
  <cp:lastModifiedBy>Baik, Seo (NIH/NLM/LHC) [E]</cp:lastModifiedBy>
  <cp:revision>2</cp:revision>
  <dcterms:created xsi:type="dcterms:W3CDTF">2023-03-23T15:19:14Z</dcterms:created>
  <dcterms:modified xsi:type="dcterms:W3CDTF">2023-09-28T16:02:13Z</dcterms:modified>
</cp:coreProperties>
</file>